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73" r:id="rId2"/>
  </p:sldIdLst>
  <p:sldSz cx="12192000" cy="6858000"/>
  <p:notesSz cx="6858000" cy="9144000"/>
  <p:defaultTextStyle>
    <a:defPPr>
      <a:defRPr lang="en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gne Torsteinsen" initials="MT" lastIdx="3" clrIdx="0">
    <p:extLst>
      <p:ext uri="{19B8F6BF-5375-455C-9EA6-DF929625EA0E}">
        <p15:presenceInfo xmlns:p15="http://schemas.microsoft.com/office/powerpoint/2012/main" userId="17917a3f2741f5cd" providerId="Windows Live"/>
      </p:ext>
    </p:extLst>
  </p:cmAuthor>
  <p:cmAuthor id="2" name="Bjørn Henning Grønberg" initials="BHG" lastIdx="1" clrIdx="1">
    <p:extLst>
      <p:ext uri="{19B8F6BF-5375-455C-9EA6-DF929625EA0E}">
        <p15:presenceInfo xmlns:p15="http://schemas.microsoft.com/office/powerpoint/2012/main" userId="S::bjorngro@ntnu.no::b316562d-1c21-4848-ac10-19aa15ea7fa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761"/>
  </p:normalViewPr>
  <p:slideViewPr>
    <p:cSldViewPr snapToGrid="0" snapToObjects="1">
      <p:cViewPr varScale="1">
        <p:scale>
          <a:sx n="110" d="100"/>
          <a:sy n="110" d="100"/>
        </p:scale>
        <p:origin x="63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91EF72-ABB2-7440-93DC-2BB7C67361A7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BD99CC-9C04-D84F-A3E7-ADEC9CE63AA7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7716474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4E824E-3078-4C4F-9965-09CB19FE086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8865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AB675-A36C-2943-9172-F71ECD0931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F9BAF8-CA78-2340-95C4-FCA49BE2BE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AE6994-9C5B-6844-AB61-F638A4BF9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E80A70-087B-A34E-A51D-5E6AF8E77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40EAF3-0B1B-0747-AC2E-925E4C418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018144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C2BFE-9F93-F34B-9ACC-FF96D8645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32F26A-B9AC-6743-A9F5-B44C9E1DCE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363A0A-61FC-EF41-B970-014352D62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360227-8D8D-6245-83B5-A0B7E86C1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AFDDB9-E11E-E248-81AF-B9D8187BD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971948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F2048D-3B95-2F41-83BB-5DADB9397D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8CD1E4-358A-3D49-87AB-B567689682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B1ED8-3124-D849-BF07-F90E8E053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53B1F-76ED-594F-BDBA-AE3BBD60C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64438-BC00-4849-8E04-3A03F9238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747331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06DC9-D72B-3747-B1E3-AD673FB9C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F3B271-D1DB-AB4B-A402-02479E9432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C53F3-FE15-DF47-A887-063281FBD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508CD3-3128-4845-A8BF-34A53E76B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B76C30-A8E2-D64B-9819-288E63A6A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23392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CE79D0-986D-334B-BCCB-06D02BB7E1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7BE21B-3A79-6446-AB14-389CE5ACE2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70317-8AC5-EA43-B6DD-D24573010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C75F9-4411-E641-AF1C-7C6EC2227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91BA16-FB7A-7B40-9464-BD3543014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167600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F122C-2FC4-7043-B13F-CD8F771FE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758CC3-81C4-1E48-BFAC-D47475C461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8FB78B-7B80-534F-BB53-DB6BEE1A0C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0E8FA8-5826-7442-A4CF-5C6B5EAAC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6BBD2-8EC9-444D-9FBF-A6B50DAB9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12FB5A-8551-2148-8DF0-574BDABB6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524426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7ED63D-B2CF-F145-9ACF-0AD2709B6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F534BD-178E-F444-A359-61B32FD23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832DAA-C431-8240-8901-DBA8DF13C1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22558A-F6DF-8D43-9FD4-C2DEA420BC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947DA6-A64D-5142-A199-66B6B1A5BE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D39897-4C6B-544A-98C0-AAB414459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99F35B-8363-1A49-8EF6-1FA903850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FB76F2-16AB-6441-A1A3-380D1BA1A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4263608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B6A9D-A0A0-7042-8E58-02D6B36844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685548-FA9D-A742-B029-FB2B81779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C009FD-C0B8-2844-A918-B37077070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37CBF2-2ED7-6445-9485-5CA63ED63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488584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F744D7-21DD-8547-924F-A2A3D5B38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7CB115-F416-1C4A-ABFE-ADE1E80CF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E43913-A4BF-3A47-8918-182A3E5B4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310016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018CA-D371-074D-9682-0987FAE8E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B9ADFB-A8E9-C94D-A061-9B76A312B5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F6A483-D3CE-BD48-8B92-A7A6E29B6D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243210-C1BA-8347-BC18-8038B94CB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FCC3AF-9CB4-1346-8194-1B9877E6F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9220A1-11A6-4F4B-97C2-371A5961D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944008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A5C35-E903-1F41-A435-A1460BE56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EAC559-1091-E845-BD8C-EF61688098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76725E-A17F-2A47-B571-B83BCBFE18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E2BB18-66F0-2049-917D-71BF83CC0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2CF896-2E43-6F43-AF3F-B07A9D3EB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8801A2-925D-1948-81C3-84FCE9533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971145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4595A4-72AC-EE46-B680-A6D80A2067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5C4890-0E12-9E45-914F-61E83C6DF4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088382-35FC-6B47-AE8B-8499CC1D16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AB11AD-7AAC-094E-94CA-6B379A7FB816}" type="datetimeFigureOut">
              <a:rPr lang="en-NO" smtClean="0"/>
              <a:t>25/01/2022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80E927-F09E-A440-95EA-4621878E1B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BAA64F-C5A6-944F-843E-BE3717502F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88FA5-16AD-6A4A-9C68-F59ECB668E70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306010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Plassholder for innhold 3">
            <a:extLst>
              <a:ext uri="{FF2B5EF4-FFF2-40B4-BE49-F238E27FC236}">
                <a16:creationId xmlns:a16="http://schemas.microsoft.com/office/drawing/2014/main" id="{A91EC873-823F-4A68-9A56-47848FF83C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5149238"/>
              </p:ext>
            </p:extLst>
          </p:nvPr>
        </p:nvGraphicFramePr>
        <p:xfrm>
          <a:off x="227025" y="908190"/>
          <a:ext cx="10985915" cy="556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35290">
                  <a:extLst>
                    <a:ext uri="{9D8B030D-6E8A-4147-A177-3AD203B41FA5}">
                      <a16:colId xmlns:a16="http://schemas.microsoft.com/office/drawing/2014/main" val="2374752550"/>
                    </a:ext>
                  </a:extLst>
                </a:gridCol>
                <a:gridCol w="1612105">
                  <a:extLst>
                    <a:ext uri="{9D8B030D-6E8A-4147-A177-3AD203B41FA5}">
                      <a16:colId xmlns:a16="http://schemas.microsoft.com/office/drawing/2014/main" val="1480918841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3558163639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1024435324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1097329864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3594854495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472687062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74358844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3309255896"/>
                    </a:ext>
                  </a:extLst>
                </a:gridCol>
                <a:gridCol w="879815">
                  <a:extLst>
                    <a:ext uri="{9D8B030D-6E8A-4147-A177-3AD203B41FA5}">
                      <a16:colId xmlns:a16="http://schemas.microsoft.com/office/drawing/2014/main" val="1507727449"/>
                    </a:ext>
                  </a:extLst>
                </a:gridCol>
              </a:tblGrid>
              <a:tr h="340544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patients in </a:t>
                      </a:r>
                      <a:r>
                        <a:rPr lang="nb-NO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CT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in study cohort -both B- and E-GP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s with only </a:t>
                      </a:r>
                      <a:b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GPS or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3 course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s </a:t>
                      </a:r>
                      <a:r>
                        <a:rPr lang="nb-NO" sz="12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</a:t>
                      </a:r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2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y</a:t>
                      </a:r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PS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608625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232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3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70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2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210181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endParaRPr 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3823171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(range)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67 (46-83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 (47-83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nb-NO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 (46-83)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 (53-82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5860508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6)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9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1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2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4446570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4)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1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9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8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5517275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b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7)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6315430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3)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4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0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2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6380697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O PS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3)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6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4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2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3528786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3)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8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7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2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3183526"/>
                  </a:ext>
                </a:extLst>
              </a:tr>
              <a:tr h="340544">
                <a:tc>
                  <a:txBody>
                    <a:bodyPr/>
                    <a:lstStyle/>
                    <a:p>
                      <a:pPr algn="l"/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4)</a:t>
                      </a:r>
                      <a:endParaRPr lang="en-GB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" charset="0"/>
                        <a:cs typeface="Times New Roman" panose="02020603050405020304" pitchFamily="18" charset="0"/>
                      </a:endParaRP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9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6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8616804"/>
                  </a:ext>
                </a:extLst>
              </a:tr>
              <a:tr h="340544">
                <a:tc rowSpan="3"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ization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127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(55)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2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1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0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2182999"/>
                  </a:ext>
                </a:extLst>
              </a:tr>
              <a:tr h="340544">
                <a:tc vMerge="1">
                  <a:txBody>
                    <a:bodyPr/>
                    <a:lstStyle/>
                    <a:p>
                      <a:pPr algn="l"/>
                      <a:endParaRPr lang="en-US" sz="7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servation</a:t>
                      </a:r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m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(22)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8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9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0751039"/>
                  </a:ext>
                </a:extLst>
              </a:tr>
              <a:tr h="340544">
                <a:tc vMerge="1">
                  <a:txBody>
                    <a:bodyPr/>
                    <a:lstStyle/>
                    <a:p>
                      <a:pPr algn="l"/>
                      <a:endParaRPr lang="en-US" sz="7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intenance</a:t>
                      </a:r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m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(23)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0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1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0242198"/>
                  </a:ext>
                </a:extLst>
              </a:tr>
              <a:tr h="340544">
                <a:tc rowSpan="2"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eived</a:t>
                      </a:r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therapy</a:t>
                      </a:r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ter</a:t>
                      </a:r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therapy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182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(78)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74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0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3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9526300"/>
                  </a:ext>
                </a:extLst>
              </a:tr>
              <a:tr h="340544">
                <a:tc vMerge="1">
                  <a:txBody>
                    <a:bodyPr/>
                    <a:lstStyle/>
                    <a:p>
                      <a:pPr algn="l"/>
                      <a:endParaRPr 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b-NO" sz="10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" charset="0"/>
                          <a:cs typeface="Times New Roman" panose="02020603050405020304" pitchFamily="18" charset="0"/>
                        </a:rPr>
                        <a:t>(22)</a:t>
                      </a:r>
                    </a:p>
                  </a:txBody>
                  <a:tcPr marL="60960" marR="6096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6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b-NO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7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0751371"/>
                  </a:ext>
                </a:extLst>
              </a:tr>
            </a:tbl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01774ECD-FA89-48FB-950D-EA63C2E7EA6F}"/>
              </a:ext>
            </a:extLst>
          </p:cNvPr>
          <p:cNvSpPr txBox="1">
            <a:spLocks/>
          </p:cNvSpPr>
          <p:nvPr/>
        </p:nvSpPr>
        <p:spPr>
          <a:xfrm>
            <a:off x="227025" y="234051"/>
            <a:ext cx="11292851" cy="30079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- Baseline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horts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r>
              <a:rPr lang="nb-NO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nb-NO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endParaRPr lang="en-NO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575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8</Words>
  <Application>Microsoft Macintosh PowerPoint</Application>
  <PresentationFormat>Widescreen</PresentationFormat>
  <Paragraphs>1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e Søfteland Sandvei</dc:creator>
  <cp:lastModifiedBy>Marie Søfteland Sandvei</cp:lastModifiedBy>
  <cp:revision>18</cp:revision>
  <dcterms:created xsi:type="dcterms:W3CDTF">2021-08-21T17:04:28Z</dcterms:created>
  <dcterms:modified xsi:type="dcterms:W3CDTF">2022-01-25T21:42:51Z</dcterms:modified>
</cp:coreProperties>
</file>